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67" r:id="rId2"/>
  </p:sldIdLst>
  <p:sldSz cx="6858000" cy="9906000" type="A4"/>
  <p:notesSz cx="7019925" cy="9305925"/>
  <p:defaultTextStyle>
    <a:defPPr>
      <a:defRPr lang="en-US"/>
    </a:defPPr>
    <a:lvl1pPr marL="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420A85-522C-BA67-B114-0A65795EA956}" name="Okada, Hideho" initials="OH" userId="S::Hideho.Okada@ucsf.edu::671511d3-cd11-4160-9944-e95e2d6f640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ada, Hideho" initials="O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00"/>
    <a:srgbClr val="FD8008"/>
    <a:srgbClr val="59F0FF"/>
    <a:srgbClr val="CF4A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淡色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282" autoAdjust="0"/>
    <p:restoredTop sz="94219" autoAdjust="0"/>
  </p:normalViewPr>
  <p:slideViewPr>
    <p:cSldViewPr snapToGrid="0" snapToObjects="1">
      <p:cViewPr varScale="1">
        <p:scale>
          <a:sx n="72" d="100"/>
          <a:sy n="72" d="100"/>
        </p:scale>
        <p:origin x="2640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CA6C8B2-6FEF-A547-8646-0FE457AC1EC1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1875" y="698500"/>
            <a:ext cx="24161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ACD0EFB0-D434-0B49-A28D-5FCF7DE0E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2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0EFB0-D434-0B49-A28D-5FCF7DE0E70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5092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1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0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3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0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529703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529703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8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700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00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8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7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5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4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2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1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19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08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10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41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7" y="2217384"/>
            <a:ext cx="3030143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7" y="3141486"/>
            <a:ext cx="3030143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217384"/>
            <a:ext cx="3031331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9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4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94422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072934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95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00"/>
            </a:lvl1pPr>
            <a:lvl2pPr marL="478850" indent="0">
              <a:buNone/>
              <a:defRPr sz="2900"/>
            </a:lvl2pPr>
            <a:lvl3pPr marL="957700" indent="0">
              <a:buNone/>
              <a:defRPr sz="2500"/>
            </a:lvl3pPr>
            <a:lvl4pPr marL="1436551" indent="0">
              <a:buNone/>
              <a:defRPr sz="2100"/>
            </a:lvl4pPr>
            <a:lvl5pPr marL="1915402" indent="0">
              <a:buNone/>
              <a:defRPr sz="2100"/>
            </a:lvl5pPr>
            <a:lvl6pPr marL="2394252" indent="0">
              <a:buNone/>
              <a:defRPr sz="2100"/>
            </a:lvl6pPr>
            <a:lvl7pPr marL="2873102" indent="0">
              <a:buNone/>
              <a:defRPr sz="2100"/>
            </a:lvl7pPr>
            <a:lvl8pPr marL="3351952" indent="0">
              <a:buNone/>
              <a:defRPr sz="2100"/>
            </a:lvl8pPr>
            <a:lvl9pPr marL="383080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9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3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5770" tIns="47886" rIns="95770" bIns="4788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9"/>
            <a:ext cx="6172200" cy="6537502"/>
          </a:xfrm>
          <a:prstGeom prst="rect">
            <a:avLst/>
          </a:prstGeom>
        </p:spPr>
        <p:txBody>
          <a:bodyPr vert="horz" lIns="95770" tIns="47886" rIns="95770" bIns="4788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10"/>
            <a:ext cx="21717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8850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38" indent="-359138" algn="l" defTabSz="478850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132" indent="-299281" algn="l" defTabSz="478850" rtl="0" eaLnBrk="1" latinLnBrk="0" hangingPunct="1">
        <a:spcBef>
          <a:spcPct val="20000"/>
        </a:spcBef>
        <a:buFont typeface="Arial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126" indent="-239425" algn="l" defTabSz="47885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5976" indent="-239425" algn="l" defTabSz="47885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826" indent="-239425" algn="l" defTabSz="478850" rtl="0" eaLnBrk="1" latinLnBrk="0" hangingPunct="1">
        <a:spcBef>
          <a:spcPct val="20000"/>
        </a:spcBef>
        <a:buFont typeface="Arial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67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52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37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22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85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70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551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4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2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1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19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0803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図 48">
            <a:extLst>
              <a:ext uri="{FF2B5EF4-FFF2-40B4-BE49-F238E27FC236}">
                <a16:creationId xmlns:a16="http://schemas.microsoft.com/office/drawing/2014/main" id="{35DE7F8E-B806-FE96-30EF-B39D95BCB6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3093" y="2298602"/>
            <a:ext cx="1221943" cy="118800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59179E06-7FDD-E01D-2A5B-5A63EACB06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6147" y="2298602"/>
            <a:ext cx="1221943" cy="1188000"/>
          </a:xfrm>
          <a:prstGeom prst="rect">
            <a:avLst/>
          </a:prstGeom>
        </p:spPr>
      </p:pic>
      <p:pic>
        <p:nvPicPr>
          <p:cNvPr id="2" name="図 1" descr="co-cul(1)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589"/>
          <a:stretch/>
        </p:blipFill>
        <p:spPr>
          <a:xfrm>
            <a:off x="469517" y="316350"/>
            <a:ext cx="5040000" cy="1531543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301421" y="2083158"/>
            <a:ext cx="108976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WT-T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46968" y="2097414"/>
            <a:ext cx="1467068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CAR-T without pretreatment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852478" y="2083158"/>
            <a:ext cx="110650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Met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139179" y="2083158"/>
            <a:ext cx="110961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Rap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418993" y="2083158"/>
            <a:ext cx="663964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</a:t>
            </a:r>
            <a:r>
              <a:rPr kumimoji="1" lang="en-US" altLang="ja-JP" sz="800" dirty="0" err="1">
                <a:latin typeface="Helvetica" pitchFamily="2" charset="0"/>
              </a:rPr>
              <a:t>Met+Rap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43" name="TextBox 422"/>
          <p:cNvSpPr txBox="1"/>
          <p:nvPr/>
        </p:nvSpPr>
        <p:spPr>
          <a:xfrm>
            <a:off x="36056" y="741935"/>
            <a:ext cx="29600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A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554872" y="1350664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219110" y="1350182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779428" y="1350664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9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318513" y="13506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5" name="TextBox 422"/>
          <p:cNvSpPr txBox="1"/>
          <p:nvPr/>
        </p:nvSpPr>
        <p:spPr>
          <a:xfrm>
            <a:off x="18121" y="1847893"/>
            <a:ext cx="29605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B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D44D1C4-F201-BE80-6BA7-55481789E2B1}"/>
              </a:ext>
            </a:extLst>
          </p:cNvPr>
          <p:cNvSpPr txBox="1"/>
          <p:nvPr/>
        </p:nvSpPr>
        <p:spPr>
          <a:xfrm>
            <a:off x="7697" y="27852"/>
            <a:ext cx="279435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2</a:t>
            </a:r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87D5400-2401-BE1D-01A0-0DCB55C09CD6}"/>
              </a:ext>
            </a:extLst>
          </p:cNvPr>
          <p:cNvSpPr txBox="1"/>
          <p:nvPr/>
        </p:nvSpPr>
        <p:spPr>
          <a:xfrm>
            <a:off x="296868" y="603718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Spleen of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AR-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Tg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ous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13390CA-568E-8AB3-445A-8DDD98D762AB}"/>
              </a:ext>
            </a:extLst>
          </p:cNvPr>
          <p:cNvSpPr txBox="1"/>
          <p:nvPr/>
        </p:nvSpPr>
        <p:spPr>
          <a:xfrm>
            <a:off x="1781206" y="619543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etabolic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regulator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72AF789-C417-E8FD-D7BF-08B91A3FE172}"/>
              </a:ext>
            </a:extLst>
          </p:cNvPr>
          <p:cNvSpPr txBox="1"/>
          <p:nvPr/>
        </p:nvSpPr>
        <p:spPr>
          <a:xfrm>
            <a:off x="3516856" y="810553"/>
            <a:ext cx="7069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endParaRPr kumimoji="1" lang="en-US" altLang="ja-JP" sz="800" dirty="0">
              <a:latin typeface="Helvetica" pitchFamily="2" charset="0"/>
              <a:cs typeface="Arial"/>
            </a:endParaRP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AR-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E2775B5-E2BF-3F2C-1189-F7DC50EB0959}"/>
              </a:ext>
            </a:extLst>
          </p:cNvPr>
          <p:cNvSpPr txBox="1"/>
          <p:nvPr/>
        </p:nvSpPr>
        <p:spPr>
          <a:xfrm>
            <a:off x="1068734" y="578405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D3 and CD28 stimulation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040970-EED5-4D44-CD5A-386628935393}"/>
              </a:ext>
            </a:extLst>
          </p:cNvPr>
          <p:cNvSpPr txBox="1"/>
          <p:nvPr/>
        </p:nvSpPr>
        <p:spPr>
          <a:xfrm>
            <a:off x="2593363" y="373322"/>
            <a:ext cx="899788" cy="7078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Remove metabolic regulator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expand with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02FCCF0-7599-D078-57CC-9FEC21D75673}"/>
              </a:ext>
            </a:extLst>
          </p:cNvPr>
          <p:cNvSpPr txBox="1"/>
          <p:nvPr/>
        </p:nvSpPr>
        <p:spPr>
          <a:xfrm>
            <a:off x="4106696" y="1237173"/>
            <a:ext cx="109976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Flow Cytometry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id="{D5F718B6-4622-5DE0-B21B-02B239E44E6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15313" y="2298602"/>
            <a:ext cx="1221943" cy="1188000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831A4C31-0F0D-D240-2FBC-09F80DC4F85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97533" y="2298602"/>
            <a:ext cx="1221943" cy="1188000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6635209B-E811-B2BC-419F-55FF7AECA0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79753" y="2298602"/>
            <a:ext cx="1221943" cy="1188000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F042236B-2E80-A6BC-9C28-5CFAB6CACA5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6147" y="3720594"/>
            <a:ext cx="1221943" cy="1188000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530ABDCA-B873-738C-2F9C-81624821F49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33093" y="3720594"/>
            <a:ext cx="1221943" cy="1188000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F877147B-AA39-9894-1742-9F740255A68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15313" y="3720594"/>
            <a:ext cx="1221943" cy="1188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F3DD746A-38E1-7DA4-0D47-F5D773F22C0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97533" y="3720594"/>
            <a:ext cx="1221943" cy="1188000"/>
          </a:xfrm>
          <a:prstGeom prst="rect">
            <a:avLst/>
          </a:prstGeom>
        </p:spPr>
      </p:pic>
      <p:pic>
        <p:nvPicPr>
          <p:cNvPr id="57" name="図 56">
            <a:extLst>
              <a:ext uri="{FF2B5EF4-FFF2-40B4-BE49-F238E27FC236}">
                <a16:creationId xmlns:a16="http://schemas.microsoft.com/office/drawing/2014/main" id="{8B7F97E0-D7A1-673A-4330-0E20B2ECEFC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79753" y="3720594"/>
            <a:ext cx="1221943" cy="1188000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EA522554-B501-3806-932C-B378F9BA143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6147" y="5141170"/>
            <a:ext cx="1221943" cy="1188000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31A67632-1211-F313-7CE6-BB5636D4195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33093" y="5141170"/>
            <a:ext cx="1221943" cy="118800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8C092124-3602-6EF1-5CB9-8F05AACB51D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715313" y="5141170"/>
            <a:ext cx="1221943" cy="1188000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A74E4F77-D609-6271-F9F6-7EAF1CAD9FD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997533" y="5141170"/>
            <a:ext cx="1221943" cy="1188000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C97AE943-28D2-3B51-6C90-ED40832DC04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279753" y="5141170"/>
            <a:ext cx="1221943" cy="1188000"/>
          </a:xfrm>
          <a:prstGeom prst="rect">
            <a:avLst/>
          </a:prstGeom>
        </p:spPr>
      </p:pic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1BBD9AB-4087-7844-AB8E-88457795B3D5}"/>
              </a:ext>
            </a:extLst>
          </p:cNvPr>
          <p:cNvGrpSpPr/>
          <p:nvPr/>
        </p:nvGrpSpPr>
        <p:grpSpPr>
          <a:xfrm>
            <a:off x="11176" y="2465770"/>
            <a:ext cx="1127395" cy="1186250"/>
            <a:chOff x="150207" y="8469074"/>
            <a:chExt cx="1127395" cy="1186250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5176F1EC-69F7-5067-7099-C36F0E1D408F}"/>
                </a:ext>
              </a:extLst>
            </p:cNvPr>
            <p:cNvSpPr txBox="1"/>
            <p:nvPr/>
          </p:nvSpPr>
          <p:spPr>
            <a:xfrm>
              <a:off x="830043" y="9439880"/>
              <a:ext cx="4475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CD44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7F4D3C17-C425-C0BF-7EB2-51353C2394B5}"/>
                </a:ext>
              </a:extLst>
            </p:cNvPr>
            <p:cNvSpPr txBox="1"/>
            <p:nvPr/>
          </p:nvSpPr>
          <p:spPr>
            <a:xfrm rot="16200000">
              <a:off x="5295" y="8613986"/>
              <a:ext cx="5052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CD62L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29EF4BAD-9B74-BC27-BF90-983EBE2F8EE0}"/>
                </a:ext>
              </a:extLst>
            </p:cNvPr>
            <p:cNvCxnSpPr/>
            <p:nvPr/>
          </p:nvCxnSpPr>
          <p:spPr>
            <a:xfrm>
              <a:off x="250990" y="9551483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矢印コネクタ 6">
              <a:extLst>
                <a:ext uri="{FF2B5EF4-FFF2-40B4-BE49-F238E27FC236}">
                  <a16:creationId xmlns:a16="http://schemas.microsoft.com/office/drawing/2014/main" id="{B07335C8-D284-9F88-9517-6D01FB0128F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64124" y="9234361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8F9305F-5D02-D3A6-90AE-B9CEDA311BE0}"/>
              </a:ext>
            </a:extLst>
          </p:cNvPr>
          <p:cNvGrpSpPr/>
          <p:nvPr/>
        </p:nvGrpSpPr>
        <p:grpSpPr>
          <a:xfrm>
            <a:off x="14289" y="3977159"/>
            <a:ext cx="1071256" cy="1102443"/>
            <a:chOff x="150208" y="8552881"/>
            <a:chExt cx="1071256" cy="1102443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D94D63B-11B4-2A20-7AB3-C3AE422E6984}"/>
                </a:ext>
              </a:extLst>
            </p:cNvPr>
            <p:cNvSpPr txBox="1"/>
            <p:nvPr/>
          </p:nvSpPr>
          <p:spPr>
            <a:xfrm>
              <a:off x="836422" y="9439880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PD1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373216F-AF36-1F96-277C-22040D5F47FA}"/>
                </a:ext>
              </a:extLst>
            </p:cNvPr>
            <p:cNvSpPr txBox="1"/>
            <p:nvPr/>
          </p:nvSpPr>
          <p:spPr>
            <a:xfrm rot="16200000">
              <a:off x="51783" y="8651306"/>
              <a:ext cx="4122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Tim3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6C6963BE-F31C-E49D-2ADC-D33A7461E15F}"/>
                </a:ext>
              </a:extLst>
            </p:cNvPr>
            <p:cNvCxnSpPr/>
            <p:nvPr/>
          </p:nvCxnSpPr>
          <p:spPr>
            <a:xfrm>
              <a:off x="250990" y="9551483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4A5F14B2-F82C-26D2-DEC4-C98D8DB700B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64124" y="9234361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47108BEB-0237-28C1-C63A-338966864FF3}"/>
              </a:ext>
            </a:extLst>
          </p:cNvPr>
          <p:cNvGrpSpPr/>
          <p:nvPr/>
        </p:nvGrpSpPr>
        <p:grpSpPr>
          <a:xfrm>
            <a:off x="11181" y="5381690"/>
            <a:ext cx="1082477" cy="1131714"/>
            <a:chOff x="150208" y="8523610"/>
            <a:chExt cx="1082477" cy="1131714"/>
          </a:xfrm>
        </p:grpSpPr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CA47242C-BDF7-1FE2-7C5D-B8CBCD0D4D9F}"/>
                </a:ext>
              </a:extLst>
            </p:cNvPr>
            <p:cNvSpPr txBox="1"/>
            <p:nvPr/>
          </p:nvSpPr>
          <p:spPr>
            <a:xfrm>
              <a:off x="825201" y="9439880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err="1">
                  <a:latin typeface="Helvetica" pitchFamily="2" charset="0"/>
                </a:rPr>
                <a:t>IFNγ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9824479-AE4F-F53C-905B-760D7F3B0013}"/>
                </a:ext>
              </a:extLst>
            </p:cNvPr>
            <p:cNvSpPr txBox="1"/>
            <p:nvPr/>
          </p:nvSpPr>
          <p:spPr>
            <a:xfrm rot="16200000">
              <a:off x="34952" y="8638866"/>
              <a:ext cx="4459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TNFα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C5C8426D-DCEE-7A38-D2C6-51A3711B4350}"/>
                </a:ext>
              </a:extLst>
            </p:cNvPr>
            <p:cNvCxnSpPr/>
            <p:nvPr/>
          </p:nvCxnSpPr>
          <p:spPr>
            <a:xfrm>
              <a:off x="250990" y="9551483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07DC9F3E-568C-F162-89FA-682781C36CB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64124" y="9234361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B6A84324-3252-A7E9-F149-D9035DCC5E8D}"/>
              </a:ext>
            </a:extLst>
          </p:cNvPr>
          <p:cNvSpPr/>
          <p:nvPr/>
        </p:nvSpPr>
        <p:spPr>
          <a:xfrm>
            <a:off x="6700" y="6654819"/>
            <a:ext cx="6862229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Helvetica" pitchFamily="2" charset="0"/>
                <a:cs typeface="Arial"/>
              </a:rPr>
              <a:t>Supplementary Figure 2. Pretreatment with metabolic regulators preserves the central memory phenotype and prevents the exhaustion of CAR-T cells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A) Experimental design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B) Flow cytometric plots for CD44 and CD62L (upper panels), PD1 and Tim3 (middle panels), and </a:t>
            </a:r>
            <a:r>
              <a:rPr lang="en-US" altLang="ja-JP" sz="1100" dirty="0" err="1">
                <a:latin typeface="Helvetica" pitchFamily="2" charset="0"/>
                <a:cs typeface="Arial"/>
              </a:rPr>
              <a:t>IFNg</a:t>
            </a:r>
            <a:r>
              <a:rPr lang="en-US" altLang="ja-JP" sz="1100" dirty="0">
                <a:latin typeface="Helvetica" pitchFamily="2" charset="0"/>
                <a:cs typeface="Arial"/>
              </a:rPr>
              <a:t> and TNF</a:t>
            </a:r>
            <a:r>
              <a:rPr lang="el-GR" altLang="ja-JP" sz="1100" dirty="0">
                <a:latin typeface="Helvetica" pitchFamily="2" charset="0"/>
                <a:cs typeface="Arial"/>
              </a:rPr>
              <a:t>α (</a:t>
            </a:r>
            <a:r>
              <a:rPr lang="en-US" altLang="ja-JP" sz="1100" dirty="0">
                <a:latin typeface="Helvetica" pitchFamily="2" charset="0"/>
                <a:cs typeface="Arial"/>
              </a:rPr>
              <a:t>lower panels) in CD8+ cells on Day 15.</a:t>
            </a:r>
          </a:p>
          <a:p>
            <a:endParaRPr lang="en-US" altLang="ja-JP" sz="1100" dirty="0">
              <a:latin typeface="Helvetica" pitchFamily="2" charset="0"/>
              <a:cs typeface="Arial"/>
            </a:endParaRPr>
          </a:p>
          <a:p>
            <a:endParaRPr lang="ja-JP" altLang="ja-JP" sz="1100" dirty="0">
              <a:latin typeface="Helvetica" pitchFamily="2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3953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125</TotalTime>
  <Words>124</Words>
  <Application>Microsoft Macintosh PowerPoint</Application>
  <PresentationFormat>A4 210 x 297 mm</PresentationFormat>
  <Paragraphs>3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ji Chamoto</dc:creator>
  <cp:lastModifiedBy>Hatae, Ryusuke</cp:lastModifiedBy>
  <cp:revision>2323</cp:revision>
  <cp:lastPrinted>2018-12-15T02:05:20Z</cp:lastPrinted>
  <dcterms:created xsi:type="dcterms:W3CDTF">2016-02-09T23:14:56Z</dcterms:created>
  <dcterms:modified xsi:type="dcterms:W3CDTF">2023-11-13T18:24:56Z</dcterms:modified>
</cp:coreProperties>
</file>